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D2A19-F03C-6598-1EF6-3630BA6E1C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E305A2-2041-4BE8-B718-5991974AA7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F4B767-2643-8FF4-0E22-375C69AB2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02D6C0-5FD8-E611-F04D-02486D09D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118920-18AC-E7CD-B832-2A37A6A05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001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653F3E-E743-7341-F5B9-66692FD830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1FDFF0-850F-8FFB-3428-682BB5DB9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FB6DB5-E267-7F2C-E6B9-7568D03A0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46EA48-1FEB-726C-4820-A8A0A2B80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441FE1-0067-80A6-B5BD-3967C1157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794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31EEFD-0A02-9156-52B7-D3F46BAA70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10F01C-8716-D02B-F9B6-2FFA8CB265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184A7E-CD2E-BD2C-2300-93254CE90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68ED55-41DB-2BE8-2521-126C0D01C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F897A4-4651-DF62-83E6-24D72E13D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834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0E8FE-0814-3A27-6EBA-EB027CE82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B302EC-6083-E232-7E92-9AE259B955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453C3C-2346-4C2E-529D-DC07C37BD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706139-D751-D6BF-79FA-8BA9B0D79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394466-6248-446D-276A-27F1CFA05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535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A38C1-F453-8B8D-2BD5-23E8C90756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C1E381-35E4-CCA3-F8D5-16A47352B9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02A73-304B-C0A4-CA7E-1363849AD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4328BD-7093-095B-0D63-CDFE121A0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CD21D9-E2A4-7183-3543-BF8AB3762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120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91E5A-7AC7-10DA-9C8C-2365F60BF1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BC0E4B-9346-B7F6-A4EB-22B17FBDD7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D0E68D-88C2-794B-FDBA-DD64D2B7ED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9F6E6A-1C6E-45D4-DC87-DC1623F76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329C5E-912B-EADF-CF51-005B2A282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57E11A-2463-6978-6618-5B1E67197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082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36715-755B-75D5-F4FD-9624E73EFD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F61670-CA41-8D8B-C5F1-A5F49B2902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7AB953-644E-A885-0CE7-0C19DC692D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71B2D1-A4C2-1B10-5969-628285436E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A4BEA8-8A8E-E709-718A-3848EAF12F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DF33C4-264D-A6F8-713B-ECE75E424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C997331-054B-ECD1-BDAB-BD4C92954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BAA56E-0425-BC50-92C8-4AF85A9A4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279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AEC3E-66EB-5DA9-FC7C-52F82827A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12E8001-E880-8236-EDFF-D95531C68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CD9FBF-4C55-3B3D-DF00-827FC6ED8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D82778-E799-0180-7C09-F952581B6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573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3E0788-A1AC-4358-A82D-476EFE290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4F40B89-9B77-BF20-4FDD-D2103B540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9899ED-DE87-491B-6062-6F3A5ADA1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308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5388C-2DC1-4B4C-FCD2-0E6BC96E2D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BA309E-6C00-C21E-6AEB-5F506569E0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2FDFA8-6286-F471-8CD7-78F9A3192C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998368-CE5D-0B08-23A3-316BF9189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D7ACCC-6ADD-8E49-CC38-9D56A57FD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90E3A3-FC1A-1260-3B21-980B15901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31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817CDE-2A48-14F2-D8C8-54A6D0C587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D04469-43C9-BF34-CAD2-A06D99987E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946A35-B616-C67A-48DF-1631929078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4C2609-F436-E9CE-2C1A-F56DD8556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F4A84C-92E8-CE1F-303A-A74E623A6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626A8F-7089-56B7-6759-86E94FB74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019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DE7BAC-63A7-AED9-38D6-2D6BFBC555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DDDC39-A239-1829-E700-18957D357C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DFBE5B-85F1-4C9F-804B-AA2DD8DCAE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36893-9522-4CBB-8764-60EAEDD6376C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BEEBA4-2A64-BE95-91F3-C62E9AEBDA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AA2CD8-BAD9-8BB7-C615-05BB7E43A3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123F2-9CA5-4807-ADA0-9EA2C5D01B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943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26B40C2-6C7A-7CFA-6F19-64161F75F7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1EDFC9CF-76A8-0252-CFE6-C9BFE11D28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46" y="3096914"/>
            <a:ext cx="11043920" cy="144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every gene  </a:t>
            </a:r>
            <a:r>
              <a:rPr kumimoji="0" lang="en-US" altLang="en-US" sz="16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shown on top) the first lanes show the expression after treatment with the control followed by treatment with the dsRNA targeting that gene.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endogenous control actin fragment product amplified is the lower 303 bp fragment, with a 475, 525, 577, 522, 486, 521 bp fragment for </a:t>
            </a:r>
            <a:r>
              <a:rPr kumimoji="0" lang="en-US" altLang="en-US" sz="1600" b="0" i="1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go-1, Rrps13, Eng1a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kumimoji="0" lang="en-US" altLang="en-US" sz="16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Chs-2, Pat-10 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kumimoji="0" lang="en-US" altLang="en-US" sz="16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c-87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pectively.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336E49E-1E75-8B0E-5C4C-8A3FE439CC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773" y="613104"/>
            <a:ext cx="11578265" cy="232790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0C291A4-6200-6D47-6312-70D513BA04FD}"/>
              </a:ext>
            </a:extLst>
          </p:cNvPr>
          <p:cNvSpPr txBox="1"/>
          <p:nvPr/>
        </p:nvSpPr>
        <p:spPr>
          <a:xfrm>
            <a:off x="756745" y="0"/>
            <a:ext cx="1119029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kumimoji="0" lang="en-US" altLang="zh-CN" sz="1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re</a:t>
            </a:r>
            <a:r>
              <a:rPr kumimoji="0" lang="en-US" altLang="en-US" sz="1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</a:t>
            </a:r>
            <a:r>
              <a: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 gels show a ladder and three (or two for </a:t>
            </a:r>
            <a:r>
              <a:rPr kumimoji="0" lang="en-US" altLang="en-U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-10</a:t>
            </a:r>
            <a:r>
              <a: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replicates of the cDNA amplified from nematode samples treated with dsRNA. </a:t>
            </a:r>
          </a:p>
        </p:txBody>
      </p:sp>
    </p:spTree>
    <p:extLst>
      <p:ext uri="{BB962C8B-B14F-4D97-AF65-F5344CB8AC3E}">
        <p14:creationId xmlns:p14="http://schemas.microsoft.com/office/powerpoint/2010/main" val="3471199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nry Shaykins</dc:creator>
  <cp:lastModifiedBy>MDPI</cp:lastModifiedBy>
  <cp:revision>3</cp:revision>
  <dcterms:created xsi:type="dcterms:W3CDTF">2023-03-07T01:49:46Z</dcterms:created>
  <dcterms:modified xsi:type="dcterms:W3CDTF">2023-07-27T06:44:24Z</dcterms:modified>
</cp:coreProperties>
</file>